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C75DA-876C-9814-7DE4-179093D68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5BA292-FE38-AEFF-D734-A5DE75EE37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41F4E-8D10-0C49-A11F-F8BB6ACDF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0E3A5-A250-A72D-0655-868102841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E4995-1A25-5613-3CB7-F8F1FBCA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1658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53C7E-249C-C608-C640-68C35A1FF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6A180C-B2AB-BFA0-1DD2-C57FFCE6D5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53947-AF88-AD42-11FB-5027FC77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1670A-E8BF-FBE7-B76E-6AAB0061A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2F002-18E4-F467-0691-217B8C11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3292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9086AB-956A-6EF1-5DBB-DC43E5DBA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4E7BCA-4ADA-1998-0E0E-F5021CC4F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48976-69F8-ED46-0B5C-F590C0710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D4A30-63B2-A4DD-4502-3B1DDB582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8DD4B-AD6E-9022-46A0-57067D699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8981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398-2E91-DCCA-7A89-1D84D13785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CC001-5649-AB4E-6494-ACD12990FE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8D962-9ED6-6567-7417-E76244A7F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149EF-7CD2-8C65-7EEB-76B4D83A3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8CDEF-2DDF-E3D9-3B5E-61A639C60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2420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82F80-993F-D2FB-0DBA-485FD4D8F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6A2D8-14C2-C746-3B1D-933005CAF8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437D5-A396-81BA-47E0-EEEFE0AFB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855B5-4FF2-A87D-2D42-1C91F9C5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100FB-51DD-A3CD-2E67-524D38891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3098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28DD7-A945-C1E3-815F-26FD23C19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54B4C6-90E7-8E99-6217-194852FC0D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02E0C6-144D-ECB8-72A3-2748FD7AE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43D97D-D2D0-176E-562F-6CFEEC3FE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2ABEDC-26DF-E91A-B279-A0E42BB3A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0BB212-CE38-9BFC-1BEE-003AE576C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78442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06D5F-0CE7-3109-267A-DDE0F6EED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CE52BF-CBF4-9A79-43C2-00FD8F604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ED3AA0-6116-EEB4-2ADD-46D16E7A9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A17345-989F-CAFF-E538-29AECBE2AE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AAA2BB-06A9-515E-E6D7-40B6761B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4B79C1-3F57-F46E-C41E-754344EB6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21308-54ED-803A-630E-076B9A425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54443E-6521-6B03-E4A5-0DF282F47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9904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E944-4B0A-DBE3-1026-336F0EA6D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9B25A-F645-7109-DFD8-8A3E209DC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3639BA-8140-AFE8-E84A-5AE1DB01F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5D4F7E-18F3-E380-29A4-A761E131A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38731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ECAAC5-A8F4-D635-2AF1-B6AF071C8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0E0357-85EC-A8C4-13EE-E9DF67E41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465C70-5E4A-37F7-0442-2A0CBD8EE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56615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85375-7F61-062D-AB1C-DF9C5654B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03E477-406E-C5F5-4B78-E5E53C0548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7B9FAC-3F01-D384-6DA5-DF78FA169F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65789E-63D7-54B7-0C33-A70C241B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7737B-EC50-0FEF-DA55-B81A8B1A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94EC0-CEAE-21D8-8AE5-5B165533C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37477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1A9F-C6F0-792B-050C-29C4DFDFD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E15C31-1847-8321-3FB3-09E6B813D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766E6-64D7-4E38-1599-707BD73E38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E8DF5-E161-B255-0C7B-9FABBF9CC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97C65-43FA-49B8-125B-AC7F7FA25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17EA60-AE12-BB00-E775-17EE0201D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42284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1378DE-852B-CFB7-9A7A-083536627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828B3-FE3D-3926-B625-63B9F59B6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7AED3-ED14-68E6-52DD-3E815FF5F7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1B404-05E3-EF5C-F3ED-A45358ABC6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35E14-3BAD-3053-0D55-C41CCC65FB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6167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3C7AB2B-981F-44E8-AFEE-85CFCBF552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20" t="-35" r="48" b="53845"/>
          <a:stretch/>
        </p:blipFill>
        <p:spPr bwMode="auto">
          <a:xfrm>
            <a:off x="4079314" y="2935916"/>
            <a:ext cx="4126457" cy="2809328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C62C5F1-0842-4AE6-8B73-B2190F52F416}"/>
              </a:ext>
            </a:extLst>
          </p:cNvPr>
          <p:cNvSpPr/>
          <p:nvPr/>
        </p:nvSpPr>
        <p:spPr>
          <a:xfrm>
            <a:off x="4485887" y="4005358"/>
            <a:ext cx="2820003" cy="28042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88CA498-96F0-444E-9E8E-EB39F95E3198}"/>
              </a:ext>
            </a:extLst>
          </p:cNvPr>
          <p:cNvSpPr txBox="1"/>
          <p:nvPr/>
        </p:nvSpPr>
        <p:spPr>
          <a:xfrm>
            <a:off x="7556939" y="3991679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3550A86-C143-4593-8DB2-D9B8FE10717E}"/>
              </a:ext>
            </a:extLst>
          </p:cNvPr>
          <p:cNvSpPr txBox="1"/>
          <p:nvPr/>
        </p:nvSpPr>
        <p:spPr>
          <a:xfrm>
            <a:off x="1014222" y="102502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12A5DBE-76AB-617A-B38E-B752E6043E32}"/>
              </a:ext>
            </a:extLst>
          </p:cNvPr>
          <p:cNvSpPr txBox="1"/>
          <p:nvPr/>
        </p:nvSpPr>
        <p:spPr>
          <a:xfrm rot="16200000">
            <a:off x="4543052" y="275942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05E4D7E-49D6-CAF4-8B23-BC124BB53587}"/>
              </a:ext>
            </a:extLst>
          </p:cNvPr>
          <p:cNvSpPr txBox="1"/>
          <p:nvPr/>
        </p:nvSpPr>
        <p:spPr>
          <a:xfrm rot="16200000">
            <a:off x="5180709" y="1549691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B63C63B-7AB1-6FD3-CC7E-F1F0BD74B64A}"/>
              </a:ext>
            </a:extLst>
          </p:cNvPr>
          <p:cNvSpPr txBox="1"/>
          <p:nvPr/>
        </p:nvSpPr>
        <p:spPr>
          <a:xfrm rot="16200000">
            <a:off x="4721169" y="2470808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BBA2B2E-3B2B-6F4E-2554-E35D826A11DD}"/>
              </a:ext>
            </a:extLst>
          </p:cNvPr>
          <p:cNvSpPr txBox="1"/>
          <p:nvPr/>
        </p:nvSpPr>
        <p:spPr>
          <a:xfrm rot="16200000">
            <a:off x="5480458" y="2350434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961FAAE-FB1B-0D47-86D6-50C130EA105B}"/>
              </a:ext>
            </a:extLst>
          </p:cNvPr>
          <p:cNvSpPr txBox="1"/>
          <p:nvPr/>
        </p:nvSpPr>
        <p:spPr>
          <a:xfrm rot="16200000">
            <a:off x="5198847" y="2523558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F8CAFFE-1ECD-65D5-85E4-916C0F422922}"/>
              </a:ext>
            </a:extLst>
          </p:cNvPr>
          <p:cNvSpPr txBox="1"/>
          <p:nvPr/>
        </p:nvSpPr>
        <p:spPr>
          <a:xfrm rot="16200000">
            <a:off x="5641555" y="1595948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CC12D26-319B-B6CF-B9DF-C2E93FD41AF6}"/>
              </a:ext>
            </a:extLst>
          </p:cNvPr>
          <p:cNvCxnSpPr>
            <a:cxnSpLocks/>
          </p:cNvCxnSpPr>
          <p:nvPr/>
        </p:nvCxnSpPr>
        <p:spPr>
          <a:xfrm>
            <a:off x="4563745" y="31034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3052C0A2-F2C8-DCD5-16BA-7B06891171A2}"/>
              </a:ext>
            </a:extLst>
          </p:cNvPr>
          <p:cNvCxnSpPr>
            <a:cxnSpLocks/>
          </p:cNvCxnSpPr>
          <p:nvPr/>
        </p:nvCxnSpPr>
        <p:spPr>
          <a:xfrm>
            <a:off x="5027571" y="31034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0E5B12F-CACC-F266-04A4-CE4797661D6D}"/>
              </a:ext>
            </a:extLst>
          </p:cNvPr>
          <p:cNvCxnSpPr>
            <a:cxnSpLocks/>
          </p:cNvCxnSpPr>
          <p:nvPr/>
        </p:nvCxnSpPr>
        <p:spPr>
          <a:xfrm>
            <a:off x="5488416" y="310319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3069854-5309-5125-3BD9-49D3BA1C3AE6}"/>
              </a:ext>
            </a:extLst>
          </p:cNvPr>
          <p:cNvCxnSpPr>
            <a:cxnSpLocks/>
          </p:cNvCxnSpPr>
          <p:nvPr/>
        </p:nvCxnSpPr>
        <p:spPr>
          <a:xfrm>
            <a:off x="5942896" y="310319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196C0A6B-C206-90B8-0E47-8D09B8081D13}"/>
              </a:ext>
            </a:extLst>
          </p:cNvPr>
          <p:cNvCxnSpPr>
            <a:cxnSpLocks/>
          </p:cNvCxnSpPr>
          <p:nvPr/>
        </p:nvCxnSpPr>
        <p:spPr>
          <a:xfrm>
            <a:off x="6392545" y="310560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F90B5A1-71DD-3E8F-CCE9-8CE85FB9DFED}"/>
              </a:ext>
            </a:extLst>
          </p:cNvPr>
          <p:cNvCxnSpPr>
            <a:cxnSpLocks/>
          </p:cNvCxnSpPr>
          <p:nvPr/>
        </p:nvCxnSpPr>
        <p:spPr>
          <a:xfrm>
            <a:off x="6849745" y="310319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D47CD128-32C2-6BF9-DE62-8F8C23CAE28F}"/>
              </a:ext>
            </a:extLst>
          </p:cNvPr>
          <p:cNvSpPr txBox="1"/>
          <p:nvPr/>
        </p:nvSpPr>
        <p:spPr>
          <a:xfrm>
            <a:off x="3973505" y="3139111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A47498D-B220-BBDE-16D5-4C74F7EF3B4A}"/>
              </a:ext>
            </a:extLst>
          </p:cNvPr>
          <p:cNvSpPr txBox="1"/>
          <p:nvPr/>
        </p:nvSpPr>
        <p:spPr>
          <a:xfrm>
            <a:off x="3592700" y="3418578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B843F06-B48D-1D71-DA6E-D195497A9565}"/>
              </a:ext>
            </a:extLst>
          </p:cNvPr>
          <p:cNvSpPr txBox="1"/>
          <p:nvPr/>
        </p:nvSpPr>
        <p:spPr>
          <a:xfrm>
            <a:off x="4485888" y="3122385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0FE475B-08C2-BA7E-C6FC-97B763E3CA8F}"/>
              </a:ext>
            </a:extLst>
          </p:cNvPr>
          <p:cNvSpPr txBox="1"/>
          <p:nvPr/>
        </p:nvSpPr>
        <p:spPr>
          <a:xfrm>
            <a:off x="4485888" y="337177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CBF34FA7-192D-401A-9787-46B59A9B98DD}"/>
              </a:ext>
            </a:extLst>
          </p:cNvPr>
          <p:cNvCxnSpPr>
            <a:cxnSpLocks/>
          </p:cNvCxnSpPr>
          <p:nvPr/>
        </p:nvCxnSpPr>
        <p:spPr>
          <a:xfrm>
            <a:off x="4137523" y="446524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6">
            <a:extLst>
              <a:ext uri="{FF2B5EF4-FFF2-40B4-BE49-F238E27FC236}">
                <a16:creationId xmlns:a16="http://schemas.microsoft.com/office/drawing/2014/main" id="{015C0B8D-58E3-4DE6-BF19-454CE4EFE6F3}"/>
              </a:ext>
            </a:extLst>
          </p:cNvPr>
          <p:cNvSpPr txBox="1"/>
          <p:nvPr/>
        </p:nvSpPr>
        <p:spPr>
          <a:xfrm>
            <a:off x="3809137" y="43231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648850D4-1A6F-4202-BA77-74E331369C68}"/>
              </a:ext>
            </a:extLst>
          </p:cNvPr>
          <p:cNvCxnSpPr>
            <a:cxnSpLocks/>
          </p:cNvCxnSpPr>
          <p:nvPr/>
        </p:nvCxnSpPr>
        <p:spPr>
          <a:xfrm>
            <a:off x="4137523" y="468827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38">
            <a:extLst>
              <a:ext uri="{FF2B5EF4-FFF2-40B4-BE49-F238E27FC236}">
                <a16:creationId xmlns:a16="http://schemas.microsoft.com/office/drawing/2014/main" id="{17857408-0151-4A47-A829-79D29D6676A7}"/>
              </a:ext>
            </a:extLst>
          </p:cNvPr>
          <p:cNvSpPr txBox="1"/>
          <p:nvPr/>
        </p:nvSpPr>
        <p:spPr>
          <a:xfrm>
            <a:off x="3809137" y="45462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10E8EB3-7ABC-44AF-817B-43C42A7602A7}"/>
              </a:ext>
            </a:extLst>
          </p:cNvPr>
          <p:cNvCxnSpPr>
            <a:cxnSpLocks/>
          </p:cNvCxnSpPr>
          <p:nvPr/>
        </p:nvCxnSpPr>
        <p:spPr>
          <a:xfrm>
            <a:off x="4143659" y="411665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0">
            <a:extLst>
              <a:ext uri="{FF2B5EF4-FFF2-40B4-BE49-F238E27FC236}">
                <a16:creationId xmlns:a16="http://schemas.microsoft.com/office/drawing/2014/main" id="{4FBBD120-0B82-462B-A1A0-ADED2852B0B5}"/>
              </a:ext>
            </a:extLst>
          </p:cNvPr>
          <p:cNvSpPr txBox="1"/>
          <p:nvPr/>
        </p:nvSpPr>
        <p:spPr>
          <a:xfrm>
            <a:off x="3815273" y="397458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58655F5B-6626-43D2-B335-371BEE968A8D}"/>
              </a:ext>
            </a:extLst>
          </p:cNvPr>
          <p:cNvCxnSpPr>
            <a:cxnSpLocks/>
          </p:cNvCxnSpPr>
          <p:nvPr/>
        </p:nvCxnSpPr>
        <p:spPr>
          <a:xfrm>
            <a:off x="4137523" y="391185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2">
            <a:extLst>
              <a:ext uri="{FF2B5EF4-FFF2-40B4-BE49-F238E27FC236}">
                <a16:creationId xmlns:a16="http://schemas.microsoft.com/office/drawing/2014/main" id="{914F6FFB-42E7-41F6-B136-B2A94CF3501B}"/>
              </a:ext>
            </a:extLst>
          </p:cNvPr>
          <p:cNvSpPr txBox="1"/>
          <p:nvPr/>
        </p:nvSpPr>
        <p:spPr>
          <a:xfrm>
            <a:off x="3809137" y="37630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DC44C71-8904-48A6-BFEC-21720B43FB9B}"/>
              </a:ext>
            </a:extLst>
          </p:cNvPr>
          <p:cNvCxnSpPr>
            <a:cxnSpLocks/>
          </p:cNvCxnSpPr>
          <p:nvPr/>
        </p:nvCxnSpPr>
        <p:spPr>
          <a:xfrm>
            <a:off x="4137523" y="379761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2">
            <a:extLst>
              <a:ext uri="{FF2B5EF4-FFF2-40B4-BE49-F238E27FC236}">
                <a16:creationId xmlns:a16="http://schemas.microsoft.com/office/drawing/2014/main" id="{2CA58868-248F-4A84-8F93-6A902DF23820}"/>
              </a:ext>
            </a:extLst>
          </p:cNvPr>
          <p:cNvSpPr txBox="1"/>
          <p:nvPr/>
        </p:nvSpPr>
        <p:spPr>
          <a:xfrm>
            <a:off x="3724177" y="363010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5580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7</cp:revision>
  <dcterms:created xsi:type="dcterms:W3CDTF">2024-08-13T14:15:55Z</dcterms:created>
  <dcterms:modified xsi:type="dcterms:W3CDTF">2024-08-14T21:58:36Z</dcterms:modified>
</cp:coreProperties>
</file>